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6" r:id="rId2"/>
  </p:sldIdLst>
  <p:sldSz cx="8601075" cy="107251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78" userDrawn="1">
          <p15:clr>
            <a:srgbClr val="F26B43"/>
          </p15:clr>
        </p15:guide>
        <p15:guide id="2" pos="2709" userDrawn="1">
          <p15:clr>
            <a:srgbClr val="F26B43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37373"/>
    <a:srgbClr val="B0B0B0"/>
    <a:srgbClr val="B5B5B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820" autoAdjust="0"/>
    <p:restoredTop sz="93448" autoAdjust="0"/>
  </p:normalViewPr>
  <p:slideViewPr>
    <p:cSldViewPr>
      <p:cViewPr varScale="1">
        <p:scale>
          <a:sx n="59" d="100"/>
          <a:sy n="59" d="100"/>
        </p:scale>
        <p:origin x="1224" y="200"/>
      </p:cViewPr>
      <p:guideLst>
        <p:guide orient="horz" pos="3378"/>
        <p:guide pos="2709"/>
      </p:guideLst>
    </p:cSldViewPr>
  </p:slideViewPr>
  <p:notesTextViewPr>
    <p:cViewPr>
      <p:scale>
        <a:sx n="50" d="100"/>
        <a:sy n="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22DBE8-44A7-4AD7-A51A-271CAFEC10AA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92338" y="1143000"/>
            <a:ext cx="24733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FA9807-1A48-4E58-956B-65D68D2E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54747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5081" y="1755251"/>
            <a:ext cx="7310914" cy="3733941"/>
          </a:xfrm>
        </p:spPr>
        <p:txBody>
          <a:bodyPr anchor="b"/>
          <a:lstStyle>
            <a:lvl1pPr algn="ctr">
              <a:defRPr sz="564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5135" y="5633187"/>
            <a:ext cx="6450806" cy="2589428"/>
          </a:xfrm>
        </p:spPr>
        <p:txBody>
          <a:bodyPr/>
          <a:lstStyle>
            <a:lvl1pPr marL="0" indent="0" algn="ctr">
              <a:buNone/>
              <a:defRPr sz="2257"/>
            </a:lvl1pPr>
            <a:lvl2pPr marL="430042" indent="0" algn="ctr">
              <a:buNone/>
              <a:defRPr sz="1881"/>
            </a:lvl2pPr>
            <a:lvl3pPr marL="860085" indent="0" algn="ctr">
              <a:buNone/>
              <a:defRPr sz="1693"/>
            </a:lvl3pPr>
            <a:lvl4pPr marL="1290127" indent="0" algn="ctr">
              <a:buNone/>
              <a:defRPr sz="1505"/>
            </a:lvl4pPr>
            <a:lvl5pPr marL="1720169" indent="0" algn="ctr">
              <a:buNone/>
              <a:defRPr sz="1505"/>
            </a:lvl5pPr>
            <a:lvl6pPr marL="2150212" indent="0" algn="ctr">
              <a:buNone/>
              <a:defRPr sz="1505"/>
            </a:lvl6pPr>
            <a:lvl7pPr marL="2580254" indent="0" algn="ctr">
              <a:buNone/>
              <a:defRPr sz="1505"/>
            </a:lvl7pPr>
            <a:lvl8pPr marL="3010296" indent="0" algn="ctr">
              <a:buNone/>
              <a:defRPr sz="1505"/>
            </a:lvl8pPr>
            <a:lvl9pPr marL="3440339" indent="0" algn="ctr">
              <a:buNone/>
              <a:defRPr sz="150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9C316-A967-4F43-87A9-62498B09E496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DD6D9-3521-4988-87F6-870FA187D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5192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9C316-A967-4F43-87A9-62498B09E496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DD6D9-3521-4988-87F6-870FA187D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4079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55145" y="571015"/>
            <a:ext cx="1854607" cy="908906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1324" y="571015"/>
            <a:ext cx="5456307" cy="908906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9C316-A967-4F43-87A9-62498B09E496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DD6D9-3521-4988-87F6-870FA187D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0957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9C316-A967-4F43-87A9-62498B09E496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DD6D9-3521-4988-87F6-870FA187D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5508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6845" y="2673842"/>
            <a:ext cx="7418427" cy="4461364"/>
          </a:xfrm>
        </p:spPr>
        <p:txBody>
          <a:bodyPr anchor="b"/>
          <a:lstStyle>
            <a:lvl1pPr>
              <a:defRPr sz="564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6845" y="7177412"/>
            <a:ext cx="7418427" cy="2346126"/>
          </a:xfrm>
        </p:spPr>
        <p:txBody>
          <a:bodyPr/>
          <a:lstStyle>
            <a:lvl1pPr marL="0" indent="0">
              <a:buNone/>
              <a:defRPr sz="2257">
                <a:solidFill>
                  <a:schemeClr val="tx1"/>
                </a:solidFill>
              </a:defRPr>
            </a:lvl1pPr>
            <a:lvl2pPr marL="430042" indent="0">
              <a:buNone/>
              <a:defRPr sz="1881">
                <a:solidFill>
                  <a:schemeClr val="tx1">
                    <a:tint val="75000"/>
                  </a:schemeClr>
                </a:solidFill>
              </a:defRPr>
            </a:lvl2pPr>
            <a:lvl3pPr marL="860085" indent="0">
              <a:buNone/>
              <a:defRPr sz="1693">
                <a:solidFill>
                  <a:schemeClr val="tx1">
                    <a:tint val="75000"/>
                  </a:schemeClr>
                </a:solidFill>
              </a:defRPr>
            </a:lvl3pPr>
            <a:lvl4pPr marL="1290127" indent="0">
              <a:buNone/>
              <a:defRPr sz="1505">
                <a:solidFill>
                  <a:schemeClr val="tx1">
                    <a:tint val="75000"/>
                  </a:schemeClr>
                </a:solidFill>
              </a:defRPr>
            </a:lvl4pPr>
            <a:lvl5pPr marL="1720169" indent="0">
              <a:buNone/>
              <a:defRPr sz="1505">
                <a:solidFill>
                  <a:schemeClr val="tx1">
                    <a:tint val="75000"/>
                  </a:schemeClr>
                </a:solidFill>
              </a:defRPr>
            </a:lvl5pPr>
            <a:lvl6pPr marL="2150212" indent="0">
              <a:buNone/>
              <a:defRPr sz="1505">
                <a:solidFill>
                  <a:schemeClr val="tx1">
                    <a:tint val="75000"/>
                  </a:schemeClr>
                </a:solidFill>
              </a:defRPr>
            </a:lvl6pPr>
            <a:lvl7pPr marL="2580254" indent="0">
              <a:buNone/>
              <a:defRPr sz="1505">
                <a:solidFill>
                  <a:schemeClr val="tx1">
                    <a:tint val="75000"/>
                  </a:schemeClr>
                </a:solidFill>
              </a:defRPr>
            </a:lvl7pPr>
            <a:lvl8pPr marL="3010296" indent="0">
              <a:buNone/>
              <a:defRPr sz="1505">
                <a:solidFill>
                  <a:schemeClr val="tx1">
                    <a:tint val="75000"/>
                  </a:schemeClr>
                </a:solidFill>
              </a:defRPr>
            </a:lvl8pPr>
            <a:lvl9pPr marL="3440339" indent="0">
              <a:buNone/>
              <a:defRPr sz="15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9C316-A967-4F43-87A9-62498B09E496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DD6D9-3521-4988-87F6-870FA187D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242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1324" y="2855075"/>
            <a:ext cx="3655457" cy="680500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54294" y="2855075"/>
            <a:ext cx="3655457" cy="680500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9C316-A967-4F43-87A9-62498B09E496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DD6D9-3521-4988-87F6-870FA187D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7845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2444" y="571017"/>
            <a:ext cx="7418427" cy="2073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2445" y="2629152"/>
            <a:ext cx="3638657" cy="1288507"/>
          </a:xfrm>
        </p:spPr>
        <p:txBody>
          <a:bodyPr anchor="b"/>
          <a:lstStyle>
            <a:lvl1pPr marL="0" indent="0">
              <a:buNone/>
              <a:defRPr sz="2257" b="1"/>
            </a:lvl1pPr>
            <a:lvl2pPr marL="430042" indent="0">
              <a:buNone/>
              <a:defRPr sz="1881" b="1"/>
            </a:lvl2pPr>
            <a:lvl3pPr marL="860085" indent="0">
              <a:buNone/>
              <a:defRPr sz="1693" b="1"/>
            </a:lvl3pPr>
            <a:lvl4pPr marL="1290127" indent="0">
              <a:buNone/>
              <a:defRPr sz="1505" b="1"/>
            </a:lvl4pPr>
            <a:lvl5pPr marL="1720169" indent="0">
              <a:buNone/>
              <a:defRPr sz="1505" b="1"/>
            </a:lvl5pPr>
            <a:lvl6pPr marL="2150212" indent="0">
              <a:buNone/>
              <a:defRPr sz="1505" b="1"/>
            </a:lvl6pPr>
            <a:lvl7pPr marL="2580254" indent="0">
              <a:buNone/>
              <a:defRPr sz="1505" b="1"/>
            </a:lvl7pPr>
            <a:lvl8pPr marL="3010296" indent="0">
              <a:buNone/>
              <a:defRPr sz="1505" b="1"/>
            </a:lvl8pPr>
            <a:lvl9pPr marL="3440339" indent="0">
              <a:buNone/>
              <a:defRPr sz="150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2445" y="3917659"/>
            <a:ext cx="3638657" cy="576228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54295" y="2629152"/>
            <a:ext cx="3656577" cy="1288507"/>
          </a:xfrm>
        </p:spPr>
        <p:txBody>
          <a:bodyPr anchor="b"/>
          <a:lstStyle>
            <a:lvl1pPr marL="0" indent="0">
              <a:buNone/>
              <a:defRPr sz="2257" b="1"/>
            </a:lvl1pPr>
            <a:lvl2pPr marL="430042" indent="0">
              <a:buNone/>
              <a:defRPr sz="1881" b="1"/>
            </a:lvl2pPr>
            <a:lvl3pPr marL="860085" indent="0">
              <a:buNone/>
              <a:defRPr sz="1693" b="1"/>
            </a:lvl3pPr>
            <a:lvl4pPr marL="1290127" indent="0">
              <a:buNone/>
              <a:defRPr sz="1505" b="1"/>
            </a:lvl4pPr>
            <a:lvl5pPr marL="1720169" indent="0">
              <a:buNone/>
              <a:defRPr sz="1505" b="1"/>
            </a:lvl5pPr>
            <a:lvl6pPr marL="2150212" indent="0">
              <a:buNone/>
              <a:defRPr sz="1505" b="1"/>
            </a:lvl6pPr>
            <a:lvl7pPr marL="2580254" indent="0">
              <a:buNone/>
              <a:defRPr sz="1505" b="1"/>
            </a:lvl7pPr>
            <a:lvl8pPr marL="3010296" indent="0">
              <a:buNone/>
              <a:defRPr sz="1505" b="1"/>
            </a:lvl8pPr>
            <a:lvl9pPr marL="3440339" indent="0">
              <a:buNone/>
              <a:defRPr sz="150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54295" y="3917659"/>
            <a:ext cx="3656577" cy="576228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9C316-A967-4F43-87A9-62498B09E496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DD6D9-3521-4988-87F6-870FA187D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063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9C316-A967-4F43-87A9-62498B09E496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DD6D9-3521-4988-87F6-870FA187D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5139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9C316-A967-4F43-87A9-62498B09E496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DD6D9-3521-4988-87F6-870FA187D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6054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2444" y="715010"/>
            <a:ext cx="2774071" cy="2502535"/>
          </a:xfrm>
        </p:spPr>
        <p:txBody>
          <a:bodyPr anchor="b"/>
          <a:lstStyle>
            <a:lvl1pPr>
              <a:defRPr sz="30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56577" y="1544225"/>
            <a:ext cx="4354294" cy="7621808"/>
          </a:xfrm>
        </p:spPr>
        <p:txBody>
          <a:bodyPr/>
          <a:lstStyle>
            <a:lvl1pPr>
              <a:defRPr sz="3010"/>
            </a:lvl1pPr>
            <a:lvl2pPr>
              <a:defRPr sz="2634"/>
            </a:lvl2pPr>
            <a:lvl3pPr>
              <a:defRPr sz="2257"/>
            </a:lvl3pPr>
            <a:lvl4pPr>
              <a:defRPr sz="1881"/>
            </a:lvl4pPr>
            <a:lvl5pPr>
              <a:defRPr sz="1881"/>
            </a:lvl5pPr>
            <a:lvl6pPr>
              <a:defRPr sz="1881"/>
            </a:lvl6pPr>
            <a:lvl7pPr>
              <a:defRPr sz="1881"/>
            </a:lvl7pPr>
            <a:lvl8pPr>
              <a:defRPr sz="1881"/>
            </a:lvl8pPr>
            <a:lvl9pPr>
              <a:defRPr sz="1881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2444" y="3217545"/>
            <a:ext cx="2774071" cy="5960900"/>
          </a:xfrm>
        </p:spPr>
        <p:txBody>
          <a:bodyPr/>
          <a:lstStyle>
            <a:lvl1pPr marL="0" indent="0">
              <a:buNone/>
              <a:defRPr sz="1505"/>
            </a:lvl1pPr>
            <a:lvl2pPr marL="430042" indent="0">
              <a:buNone/>
              <a:defRPr sz="1317"/>
            </a:lvl2pPr>
            <a:lvl3pPr marL="860085" indent="0">
              <a:buNone/>
              <a:defRPr sz="1129"/>
            </a:lvl3pPr>
            <a:lvl4pPr marL="1290127" indent="0">
              <a:buNone/>
              <a:defRPr sz="941"/>
            </a:lvl4pPr>
            <a:lvl5pPr marL="1720169" indent="0">
              <a:buNone/>
              <a:defRPr sz="941"/>
            </a:lvl5pPr>
            <a:lvl6pPr marL="2150212" indent="0">
              <a:buNone/>
              <a:defRPr sz="941"/>
            </a:lvl6pPr>
            <a:lvl7pPr marL="2580254" indent="0">
              <a:buNone/>
              <a:defRPr sz="941"/>
            </a:lvl7pPr>
            <a:lvl8pPr marL="3010296" indent="0">
              <a:buNone/>
              <a:defRPr sz="941"/>
            </a:lvl8pPr>
            <a:lvl9pPr marL="3440339" indent="0">
              <a:buNone/>
              <a:defRPr sz="94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9C316-A967-4F43-87A9-62498B09E496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DD6D9-3521-4988-87F6-870FA187D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373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2444" y="715010"/>
            <a:ext cx="2774071" cy="2502535"/>
          </a:xfrm>
        </p:spPr>
        <p:txBody>
          <a:bodyPr anchor="b"/>
          <a:lstStyle>
            <a:lvl1pPr>
              <a:defRPr sz="30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56577" y="1544225"/>
            <a:ext cx="4354294" cy="7621808"/>
          </a:xfrm>
        </p:spPr>
        <p:txBody>
          <a:bodyPr anchor="t"/>
          <a:lstStyle>
            <a:lvl1pPr marL="0" indent="0">
              <a:buNone/>
              <a:defRPr sz="3010"/>
            </a:lvl1pPr>
            <a:lvl2pPr marL="430042" indent="0">
              <a:buNone/>
              <a:defRPr sz="2634"/>
            </a:lvl2pPr>
            <a:lvl3pPr marL="860085" indent="0">
              <a:buNone/>
              <a:defRPr sz="2257"/>
            </a:lvl3pPr>
            <a:lvl4pPr marL="1290127" indent="0">
              <a:buNone/>
              <a:defRPr sz="1881"/>
            </a:lvl4pPr>
            <a:lvl5pPr marL="1720169" indent="0">
              <a:buNone/>
              <a:defRPr sz="1881"/>
            </a:lvl5pPr>
            <a:lvl6pPr marL="2150212" indent="0">
              <a:buNone/>
              <a:defRPr sz="1881"/>
            </a:lvl6pPr>
            <a:lvl7pPr marL="2580254" indent="0">
              <a:buNone/>
              <a:defRPr sz="1881"/>
            </a:lvl7pPr>
            <a:lvl8pPr marL="3010296" indent="0">
              <a:buNone/>
              <a:defRPr sz="1881"/>
            </a:lvl8pPr>
            <a:lvl9pPr marL="3440339" indent="0">
              <a:buNone/>
              <a:defRPr sz="1881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2444" y="3217545"/>
            <a:ext cx="2774071" cy="5960900"/>
          </a:xfrm>
        </p:spPr>
        <p:txBody>
          <a:bodyPr/>
          <a:lstStyle>
            <a:lvl1pPr marL="0" indent="0">
              <a:buNone/>
              <a:defRPr sz="1505"/>
            </a:lvl1pPr>
            <a:lvl2pPr marL="430042" indent="0">
              <a:buNone/>
              <a:defRPr sz="1317"/>
            </a:lvl2pPr>
            <a:lvl3pPr marL="860085" indent="0">
              <a:buNone/>
              <a:defRPr sz="1129"/>
            </a:lvl3pPr>
            <a:lvl4pPr marL="1290127" indent="0">
              <a:buNone/>
              <a:defRPr sz="941"/>
            </a:lvl4pPr>
            <a:lvl5pPr marL="1720169" indent="0">
              <a:buNone/>
              <a:defRPr sz="941"/>
            </a:lvl5pPr>
            <a:lvl6pPr marL="2150212" indent="0">
              <a:buNone/>
              <a:defRPr sz="941"/>
            </a:lvl6pPr>
            <a:lvl7pPr marL="2580254" indent="0">
              <a:buNone/>
              <a:defRPr sz="941"/>
            </a:lvl7pPr>
            <a:lvl8pPr marL="3010296" indent="0">
              <a:buNone/>
              <a:defRPr sz="941"/>
            </a:lvl8pPr>
            <a:lvl9pPr marL="3440339" indent="0">
              <a:buNone/>
              <a:defRPr sz="94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9C316-A967-4F43-87A9-62498B09E496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DD6D9-3521-4988-87F6-870FA187D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1099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1324" y="571017"/>
            <a:ext cx="7418427" cy="20730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1324" y="2855075"/>
            <a:ext cx="7418427" cy="68050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1324" y="9940627"/>
            <a:ext cx="1935242" cy="57101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2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9C316-A967-4F43-87A9-62498B09E496}" type="datetimeFigureOut">
              <a:rPr lang="zh-CN" altLang="en-US" smtClean="0"/>
              <a:t>2023/1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49106" y="9940627"/>
            <a:ext cx="2902863" cy="57101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2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074509" y="9940627"/>
            <a:ext cx="1935242" cy="57101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2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DD6D9-3521-4988-87F6-870FA187D5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6949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60085" rtl="0" eaLnBrk="1" latinLnBrk="0" hangingPunct="1">
        <a:lnSpc>
          <a:spcPct val="90000"/>
        </a:lnSpc>
        <a:spcBef>
          <a:spcPct val="0"/>
        </a:spcBef>
        <a:buNone/>
        <a:defRPr sz="413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5021" indent="-215021" algn="l" defTabSz="860085" rtl="0" eaLnBrk="1" latinLnBrk="0" hangingPunct="1">
        <a:lnSpc>
          <a:spcPct val="90000"/>
        </a:lnSpc>
        <a:spcBef>
          <a:spcPts val="941"/>
        </a:spcBef>
        <a:buFont typeface="Arial" panose="020B0604020202020204" pitchFamily="34" charset="0"/>
        <a:buChar char="•"/>
        <a:defRPr sz="2634" kern="1200">
          <a:solidFill>
            <a:schemeClr val="tx1"/>
          </a:solidFill>
          <a:latin typeface="+mn-lt"/>
          <a:ea typeface="+mn-ea"/>
          <a:cs typeface="+mn-cs"/>
        </a:defRPr>
      </a:lvl1pPr>
      <a:lvl2pPr marL="645063" indent="-215021" algn="l" defTabSz="860085" rtl="0" eaLnBrk="1" latinLnBrk="0" hangingPunct="1">
        <a:lnSpc>
          <a:spcPct val="90000"/>
        </a:lnSpc>
        <a:spcBef>
          <a:spcPts val="470"/>
        </a:spcBef>
        <a:buFont typeface="Arial" panose="020B0604020202020204" pitchFamily="34" charset="0"/>
        <a:buChar char="•"/>
        <a:defRPr sz="2257" kern="1200">
          <a:solidFill>
            <a:schemeClr val="tx1"/>
          </a:solidFill>
          <a:latin typeface="+mn-lt"/>
          <a:ea typeface="+mn-ea"/>
          <a:cs typeface="+mn-cs"/>
        </a:defRPr>
      </a:lvl2pPr>
      <a:lvl3pPr marL="1075106" indent="-215021" algn="l" defTabSz="860085" rtl="0" eaLnBrk="1" latinLnBrk="0" hangingPunct="1">
        <a:lnSpc>
          <a:spcPct val="90000"/>
        </a:lnSpc>
        <a:spcBef>
          <a:spcPts val="470"/>
        </a:spcBef>
        <a:buFont typeface="Arial" panose="020B0604020202020204" pitchFamily="34" charset="0"/>
        <a:buChar char="•"/>
        <a:defRPr sz="1881" kern="1200">
          <a:solidFill>
            <a:schemeClr val="tx1"/>
          </a:solidFill>
          <a:latin typeface="+mn-lt"/>
          <a:ea typeface="+mn-ea"/>
          <a:cs typeface="+mn-cs"/>
        </a:defRPr>
      </a:lvl3pPr>
      <a:lvl4pPr marL="1505148" indent="-215021" algn="l" defTabSz="860085" rtl="0" eaLnBrk="1" latinLnBrk="0" hangingPunct="1">
        <a:lnSpc>
          <a:spcPct val="90000"/>
        </a:lnSpc>
        <a:spcBef>
          <a:spcPts val="470"/>
        </a:spcBef>
        <a:buFont typeface="Arial" panose="020B0604020202020204" pitchFamily="34" charset="0"/>
        <a:buChar char="•"/>
        <a:defRPr sz="1693" kern="1200">
          <a:solidFill>
            <a:schemeClr val="tx1"/>
          </a:solidFill>
          <a:latin typeface="+mn-lt"/>
          <a:ea typeface="+mn-ea"/>
          <a:cs typeface="+mn-cs"/>
        </a:defRPr>
      </a:lvl4pPr>
      <a:lvl5pPr marL="1935190" indent="-215021" algn="l" defTabSz="860085" rtl="0" eaLnBrk="1" latinLnBrk="0" hangingPunct="1">
        <a:lnSpc>
          <a:spcPct val="90000"/>
        </a:lnSpc>
        <a:spcBef>
          <a:spcPts val="470"/>
        </a:spcBef>
        <a:buFont typeface="Arial" panose="020B0604020202020204" pitchFamily="34" charset="0"/>
        <a:buChar char="•"/>
        <a:defRPr sz="1693" kern="1200">
          <a:solidFill>
            <a:schemeClr val="tx1"/>
          </a:solidFill>
          <a:latin typeface="+mn-lt"/>
          <a:ea typeface="+mn-ea"/>
          <a:cs typeface="+mn-cs"/>
        </a:defRPr>
      </a:lvl5pPr>
      <a:lvl6pPr marL="2365233" indent="-215021" algn="l" defTabSz="860085" rtl="0" eaLnBrk="1" latinLnBrk="0" hangingPunct="1">
        <a:lnSpc>
          <a:spcPct val="90000"/>
        </a:lnSpc>
        <a:spcBef>
          <a:spcPts val="470"/>
        </a:spcBef>
        <a:buFont typeface="Arial" panose="020B0604020202020204" pitchFamily="34" charset="0"/>
        <a:buChar char="•"/>
        <a:defRPr sz="1693" kern="1200">
          <a:solidFill>
            <a:schemeClr val="tx1"/>
          </a:solidFill>
          <a:latin typeface="+mn-lt"/>
          <a:ea typeface="+mn-ea"/>
          <a:cs typeface="+mn-cs"/>
        </a:defRPr>
      </a:lvl6pPr>
      <a:lvl7pPr marL="2795275" indent="-215021" algn="l" defTabSz="860085" rtl="0" eaLnBrk="1" latinLnBrk="0" hangingPunct="1">
        <a:lnSpc>
          <a:spcPct val="90000"/>
        </a:lnSpc>
        <a:spcBef>
          <a:spcPts val="470"/>
        </a:spcBef>
        <a:buFont typeface="Arial" panose="020B0604020202020204" pitchFamily="34" charset="0"/>
        <a:buChar char="•"/>
        <a:defRPr sz="1693" kern="1200">
          <a:solidFill>
            <a:schemeClr val="tx1"/>
          </a:solidFill>
          <a:latin typeface="+mn-lt"/>
          <a:ea typeface="+mn-ea"/>
          <a:cs typeface="+mn-cs"/>
        </a:defRPr>
      </a:lvl7pPr>
      <a:lvl8pPr marL="3225317" indent="-215021" algn="l" defTabSz="860085" rtl="0" eaLnBrk="1" latinLnBrk="0" hangingPunct="1">
        <a:lnSpc>
          <a:spcPct val="90000"/>
        </a:lnSpc>
        <a:spcBef>
          <a:spcPts val="470"/>
        </a:spcBef>
        <a:buFont typeface="Arial" panose="020B0604020202020204" pitchFamily="34" charset="0"/>
        <a:buChar char="•"/>
        <a:defRPr sz="1693" kern="1200">
          <a:solidFill>
            <a:schemeClr val="tx1"/>
          </a:solidFill>
          <a:latin typeface="+mn-lt"/>
          <a:ea typeface="+mn-ea"/>
          <a:cs typeface="+mn-cs"/>
        </a:defRPr>
      </a:lvl8pPr>
      <a:lvl9pPr marL="3655360" indent="-215021" algn="l" defTabSz="860085" rtl="0" eaLnBrk="1" latinLnBrk="0" hangingPunct="1">
        <a:lnSpc>
          <a:spcPct val="90000"/>
        </a:lnSpc>
        <a:spcBef>
          <a:spcPts val="470"/>
        </a:spcBef>
        <a:buFont typeface="Arial" panose="020B0604020202020204" pitchFamily="34" charset="0"/>
        <a:buChar char="•"/>
        <a:defRPr sz="169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0085" rtl="0" eaLnBrk="1" latinLnBrk="0" hangingPunct="1">
        <a:defRPr sz="1693" kern="1200">
          <a:solidFill>
            <a:schemeClr val="tx1"/>
          </a:solidFill>
          <a:latin typeface="+mn-lt"/>
          <a:ea typeface="+mn-ea"/>
          <a:cs typeface="+mn-cs"/>
        </a:defRPr>
      </a:lvl1pPr>
      <a:lvl2pPr marL="430042" algn="l" defTabSz="860085" rtl="0" eaLnBrk="1" latinLnBrk="0" hangingPunct="1">
        <a:defRPr sz="1693" kern="1200">
          <a:solidFill>
            <a:schemeClr val="tx1"/>
          </a:solidFill>
          <a:latin typeface="+mn-lt"/>
          <a:ea typeface="+mn-ea"/>
          <a:cs typeface="+mn-cs"/>
        </a:defRPr>
      </a:lvl2pPr>
      <a:lvl3pPr marL="860085" algn="l" defTabSz="860085" rtl="0" eaLnBrk="1" latinLnBrk="0" hangingPunct="1">
        <a:defRPr sz="1693" kern="1200">
          <a:solidFill>
            <a:schemeClr val="tx1"/>
          </a:solidFill>
          <a:latin typeface="+mn-lt"/>
          <a:ea typeface="+mn-ea"/>
          <a:cs typeface="+mn-cs"/>
        </a:defRPr>
      </a:lvl3pPr>
      <a:lvl4pPr marL="1290127" algn="l" defTabSz="860085" rtl="0" eaLnBrk="1" latinLnBrk="0" hangingPunct="1">
        <a:defRPr sz="1693" kern="1200">
          <a:solidFill>
            <a:schemeClr val="tx1"/>
          </a:solidFill>
          <a:latin typeface="+mn-lt"/>
          <a:ea typeface="+mn-ea"/>
          <a:cs typeface="+mn-cs"/>
        </a:defRPr>
      </a:lvl4pPr>
      <a:lvl5pPr marL="1720169" algn="l" defTabSz="860085" rtl="0" eaLnBrk="1" latinLnBrk="0" hangingPunct="1">
        <a:defRPr sz="1693" kern="1200">
          <a:solidFill>
            <a:schemeClr val="tx1"/>
          </a:solidFill>
          <a:latin typeface="+mn-lt"/>
          <a:ea typeface="+mn-ea"/>
          <a:cs typeface="+mn-cs"/>
        </a:defRPr>
      </a:lvl5pPr>
      <a:lvl6pPr marL="2150212" algn="l" defTabSz="860085" rtl="0" eaLnBrk="1" latinLnBrk="0" hangingPunct="1">
        <a:defRPr sz="1693" kern="1200">
          <a:solidFill>
            <a:schemeClr val="tx1"/>
          </a:solidFill>
          <a:latin typeface="+mn-lt"/>
          <a:ea typeface="+mn-ea"/>
          <a:cs typeface="+mn-cs"/>
        </a:defRPr>
      </a:lvl6pPr>
      <a:lvl7pPr marL="2580254" algn="l" defTabSz="860085" rtl="0" eaLnBrk="1" latinLnBrk="0" hangingPunct="1">
        <a:defRPr sz="1693" kern="1200">
          <a:solidFill>
            <a:schemeClr val="tx1"/>
          </a:solidFill>
          <a:latin typeface="+mn-lt"/>
          <a:ea typeface="+mn-ea"/>
          <a:cs typeface="+mn-cs"/>
        </a:defRPr>
      </a:lvl7pPr>
      <a:lvl8pPr marL="3010296" algn="l" defTabSz="860085" rtl="0" eaLnBrk="1" latinLnBrk="0" hangingPunct="1">
        <a:defRPr sz="1693" kern="1200">
          <a:solidFill>
            <a:schemeClr val="tx1"/>
          </a:solidFill>
          <a:latin typeface="+mn-lt"/>
          <a:ea typeface="+mn-ea"/>
          <a:cs typeface="+mn-cs"/>
        </a:defRPr>
      </a:lvl8pPr>
      <a:lvl9pPr marL="3440339" algn="l" defTabSz="860085" rtl="0" eaLnBrk="1" latinLnBrk="0" hangingPunct="1">
        <a:defRPr sz="169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>
            <a:extLst>
              <a:ext uri="{FF2B5EF4-FFF2-40B4-BE49-F238E27FC236}">
                <a16:creationId xmlns:a16="http://schemas.microsoft.com/office/drawing/2014/main" id="{9F7CF54C-78FB-68A1-125D-757F3C3F03A9}"/>
              </a:ext>
            </a:extLst>
          </p:cNvPr>
          <p:cNvGrpSpPr/>
          <p:nvPr/>
        </p:nvGrpSpPr>
        <p:grpSpPr>
          <a:xfrm>
            <a:off x="1204193" y="610047"/>
            <a:ext cx="6067569" cy="7565399"/>
            <a:chOff x="1280126" y="-1440232"/>
            <a:chExt cx="8600762" cy="10723932"/>
          </a:xfrm>
        </p:grpSpPr>
        <p:pic>
          <p:nvPicPr>
            <p:cNvPr id="3" name="Picture 1">
              <a:extLst>
                <a:ext uri="{FF2B5EF4-FFF2-40B4-BE49-F238E27FC236}">
                  <a16:creationId xmlns:a16="http://schemas.microsoft.com/office/drawing/2014/main" id="{A37F8B17-5737-9C4D-C1F8-8B017DBD30A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31504" y="-1070900"/>
              <a:ext cx="8229600" cy="48514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2" name="Picture 2">
              <a:extLst>
                <a:ext uri="{FF2B5EF4-FFF2-40B4-BE49-F238E27FC236}">
                  <a16:creationId xmlns:a16="http://schemas.microsoft.com/office/drawing/2014/main" id="{A251F24F-3809-735F-BE62-7ECBB781930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51288" y="4432300"/>
              <a:ext cx="8229600" cy="48514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CD694A4F-72E9-85FA-7D62-C2C5CFF171EA}"/>
                </a:ext>
              </a:extLst>
            </p:cNvPr>
            <p:cNvSpPr txBox="1"/>
            <p:nvPr/>
          </p:nvSpPr>
          <p:spPr>
            <a:xfrm>
              <a:off x="1280126" y="-1440232"/>
              <a:ext cx="427639" cy="407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7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zh-CN" altLang="en-US" sz="127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FEEA7FBF-2CC9-61BE-B269-B0EBB0EDAB3B}"/>
                </a:ext>
              </a:extLst>
            </p:cNvPr>
            <p:cNvSpPr txBox="1"/>
            <p:nvPr/>
          </p:nvSpPr>
          <p:spPr>
            <a:xfrm>
              <a:off x="1280126" y="4043685"/>
              <a:ext cx="416276" cy="407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7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kumimoji="1" lang="zh-CN" altLang="en-US" sz="127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" name="文本框 3">
            <a:extLst>
              <a:ext uri="{FF2B5EF4-FFF2-40B4-BE49-F238E27FC236}">
                <a16:creationId xmlns:a16="http://schemas.microsoft.com/office/drawing/2014/main" id="{02D9197B-29DE-1ADE-FE40-83D5342C4C4E}"/>
              </a:ext>
            </a:extLst>
          </p:cNvPr>
          <p:cNvSpPr txBox="1"/>
          <p:nvPr/>
        </p:nvSpPr>
        <p:spPr>
          <a:xfrm>
            <a:off x="322183" y="8810953"/>
            <a:ext cx="8093432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legend</a:t>
            </a:r>
            <a:endParaRPr lang="zh-CN" altLang="zh-CN" sz="18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. S1. Total ion chromatogram of compound identification of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Huanshaodan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(A) and its drug-containing serum (B).</a:t>
            </a:r>
            <a:r>
              <a:rPr lang="zh-CN" altLang="zh-CN" dirty="0">
                <a:effectLst/>
              </a:rPr>
              <a:t> 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85455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719</TotalTime>
  <Words>26</Words>
  <Application>Microsoft Macintosh PowerPoint</Application>
  <PresentationFormat>自定义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 nn</dc:creator>
  <cp:lastModifiedBy>Su, Yunfang</cp:lastModifiedBy>
  <cp:revision>71</cp:revision>
  <dcterms:created xsi:type="dcterms:W3CDTF">2023-02-17T03:58:52Z</dcterms:created>
  <dcterms:modified xsi:type="dcterms:W3CDTF">2023-11-28T03:35:42Z</dcterms:modified>
</cp:coreProperties>
</file>